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5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04282D-75A6-4E99-BD3D-91EE54EF80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718FE6C-84A6-4971-9A8F-E37F053B53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F07D35-D41A-4840-96E6-158183218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D456-9FFC-4904-9755-4C3A5DC33E51}" type="datetimeFigureOut">
              <a:rPr lang="en-CA" smtClean="0"/>
              <a:t>2022-01-2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AA3FA5-C58C-4C26-ACD4-2EFCD8858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F1B7A0-2745-43E1-B7DF-BB6C4D73ED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C474-060A-4386-8841-5806286428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51440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5314EB-1F1D-4A11-ACEC-272C5152CC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AD1D19-0C5C-4BC6-BDA3-3590FB2B11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E153E1-1668-4EE2-AF72-CE36D082A0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D456-9FFC-4904-9755-4C3A5DC33E51}" type="datetimeFigureOut">
              <a:rPr lang="en-CA" smtClean="0"/>
              <a:t>2022-01-2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7C75B3-98BF-467F-B751-AA3B089A2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7007C8-597C-44AD-BCF8-578D00B323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C474-060A-4386-8841-5806286428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1140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9AE0199-6D0B-48A2-9A25-2B2F38A46D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660CCE-A5B7-4AB6-A4B2-EC662CF234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41B760-C2A5-43A9-941F-7C9B4B5DD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D456-9FFC-4904-9755-4C3A5DC33E51}" type="datetimeFigureOut">
              <a:rPr lang="en-CA" smtClean="0"/>
              <a:t>2022-01-2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7F2948-58BF-42F1-824C-C4A8E3058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021E7D-4E70-44ED-B762-0DAC51D9A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C474-060A-4386-8841-5806286428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90799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96E3C4-0688-445A-9B5B-D2AC70C7DD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8E13D1-20C0-416C-A016-90526007FE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AAABB8-68C6-4E5E-97FC-18F96AD60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D456-9FFC-4904-9755-4C3A5DC33E51}" type="datetimeFigureOut">
              <a:rPr lang="en-CA" smtClean="0"/>
              <a:t>2022-01-2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9641BF-7DFE-4EEB-83D3-A5640FBB49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6E0C46-1513-45F2-91E9-CA8F12E145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C474-060A-4386-8841-5806286428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16609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42DCD5-6DDE-474B-A6FA-A0A4D82997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B3886E-F51A-4C3D-A2EC-C1BFE278CF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E11DF3-D31A-4736-BBEB-D7D74B0FC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D456-9FFC-4904-9755-4C3A5DC33E51}" type="datetimeFigureOut">
              <a:rPr lang="en-CA" smtClean="0"/>
              <a:t>2022-01-2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609E68-3855-4196-8035-63401122C9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2C8C3E-297C-49D8-AC02-53933F5B4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C474-060A-4386-8841-5806286428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86529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0F7B6D-C6EB-4E55-9C25-1CD4D21050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18EDB2-7EEF-423A-9B23-F74C035CF6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2090F8-079C-41FA-B819-AE987116E6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8E6AB5-A2BF-4364-8BD1-FA7B2C297A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D456-9FFC-4904-9755-4C3A5DC33E51}" type="datetimeFigureOut">
              <a:rPr lang="en-CA" smtClean="0"/>
              <a:t>2022-01-25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E68F05-F8AD-4BC6-AD95-3518610CE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C20BA4-1509-4A9D-9754-A745DF0834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C474-060A-4386-8841-5806286428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1419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8B15DD-9B6A-4541-9778-6210FF3587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8FE32F-77B7-4491-AE68-FFE49D432D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DADFEE-06FC-44D0-B4A3-544D2B8D19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E7D8276-1643-4558-BA2E-25FA7951A8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423D38F-31C9-416E-8383-5C7684942D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2D1A278-FEDD-44D0-92DB-56B6E9722E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D456-9FFC-4904-9755-4C3A5DC33E51}" type="datetimeFigureOut">
              <a:rPr lang="en-CA" smtClean="0"/>
              <a:t>2022-01-25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3BB8F5E-BF03-44E6-B989-AC856CBD7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76DE7ED-7D71-4BFE-9633-D45A524A0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C474-060A-4386-8841-5806286428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19307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9F1120-D07A-428B-9A2D-B8CA6CEB04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32D62B-CD00-4766-88EB-952A8709CB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D456-9FFC-4904-9755-4C3A5DC33E51}" type="datetimeFigureOut">
              <a:rPr lang="en-CA" smtClean="0"/>
              <a:t>2022-01-25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602F557-B9BD-4710-8EA3-9CFB01BFB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C859A5E-40D8-4C6D-B07A-46FCC5391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C474-060A-4386-8841-5806286428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05981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BE9EAAF-9BD0-4D8C-B49F-D1974637CB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D456-9FFC-4904-9755-4C3A5DC33E51}" type="datetimeFigureOut">
              <a:rPr lang="en-CA" smtClean="0"/>
              <a:t>2022-01-25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55F4F7A-392A-406D-B151-3A2CF4C95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D8BDF1-72A0-4F73-88B3-D92675A3D5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C474-060A-4386-8841-5806286428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69499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19E91D-27C6-4EA6-89F9-A39224D8E2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CF3B72-B06B-4034-9B40-6686570CE3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334034-DE88-4267-AD84-E5C7018792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B923F7-E5BE-45B5-AABA-03D9A6170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D456-9FFC-4904-9755-4C3A5DC33E51}" type="datetimeFigureOut">
              <a:rPr lang="en-CA" smtClean="0"/>
              <a:t>2022-01-25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F0315C-962D-46D5-82E5-7ED47C2FCD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4A2F9A-FAB1-4B31-8E8E-60C137D59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C474-060A-4386-8841-5806286428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06181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20D9A8-7D37-4D7B-9897-3ACC1C26E5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0E8239-41D9-4386-A27D-2452CB9FAE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E32004-2BCA-4BEF-B510-5D619D7B2B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079C8F-7872-4E7A-B96D-DB015D8E2C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D456-9FFC-4904-9755-4C3A5DC33E51}" type="datetimeFigureOut">
              <a:rPr lang="en-CA" smtClean="0"/>
              <a:t>2022-01-25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5BF3D6-BF12-4373-A06C-2366A84D5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CC68EC-4DBD-4991-95C3-EC5FA560EE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C474-060A-4386-8841-5806286428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23467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FC73063-6394-40CD-805E-43FB96BC77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12EE5F-AA22-4FF9-AA16-CF8E5B6319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6660A4-D56A-4490-80E1-7DA3DB5C3F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29D456-9FFC-4904-9755-4C3A5DC33E51}" type="datetimeFigureOut">
              <a:rPr lang="en-CA" smtClean="0"/>
              <a:t>2022-01-2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B03996-A163-448E-8F79-33F46BBF04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802AD7-8847-48CE-B356-E458191496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31C474-060A-4386-8841-5806286428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32626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A36B083-4929-4820-B466-1144A59F2545}"/>
              </a:ext>
            </a:extLst>
          </p:cNvPr>
          <p:cNvSpPr txBox="1"/>
          <p:nvPr/>
        </p:nvSpPr>
        <p:spPr>
          <a:xfrm>
            <a:off x="348460" y="478971"/>
            <a:ext cx="3727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Sensitivity analysis for efficacy studi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3532E4B-E7E6-4002-9B58-EB286B774D4B}"/>
              </a:ext>
            </a:extLst>
          </p:cNvPr>
          <p:cNvSpPr txBox="1"/>
          <p:nvPr/>
        </p:nvSpPr>
        <p:spPr>
          <a:xfrm>
            <a:off x="7311538" y="3357976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b="1" dirty="0"/>
              <a:t>Favours contro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3E338C8-A5C8-4920-8555-2CAA6045DE1A}"/>
              </a:ext>
            </a:extLst>
          </p:cNvPr>
          <p:cNvSpPr txBox="1"/>
          <p:nvPr/>
        </p:nvSpPr>
        <p:spPr>
          <a:xfrm>
            <a:off x="8643941" y="3357976"/>
            <a:ext cx="1040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b="1" dirty="0"/>
              <a:t>Favours blue light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E1C60AA-BE9E-4FA1-A467-14258123F1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8460" y="1610723"/>
            <a:ext cx="10953473" cy="181827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9D04BD1-DA07-4C83-8BC3-70CEDF5B34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191420"/>
            <a:ext cx="12192000" cy="16904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96031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DE40F2C-E43F-4809-8E45-985F8C73FBB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4792" b="59306"/>
          <a:stretch/>
        </p:blipFill>
        <p:spPr>
          <a:xfrm>
            <a:off x="648171" y="1837678"/>
            <a:ext cx="10895658" cy="211525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F6B2F6B-9E9A-4EDD-A514-07B666051B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456" y="4721241"/>
            <a:ext cx="12136544" cy="156231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B27AB15-5AEE-4711-BC67-D5D760183B8B}"/>
              </a:ext>
            </a:extLst>
          </p:cNvPr>
          <p:cNvSpPr txBox="1"/>
          <p:nvPr/>
        </p:nvSpPr>
        <p:spPr>
          <a:xfrm>
            <a:off x="348460" y="478971"/>
            <a:ext cx="4114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Sensitivity analysis for comparison studi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B025E5C-7E8A-4C85-A9C3-A5DD8426BD5F}"/>
              </a:ext>
            </a:extLst>
          </p:cNvPr>
          <p:cNvSpPr txBox="1"/>
          <p:nvPr/>
        </p:nvSpPr>
        <p:spPr>
          <a:xfrm>
            <a:off x="7811591" y="3863642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avours contro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840358-F826-4A33-B290-4188E7E53AF6}"/>
              </a:ext>
            </a:extLst>
          </p:cNvPr>
          <p:cNvSpPr txBox="1"/>
          <p:nvPr/>
        </p:nvSpPr>
        <p:spPr>
          <a:xfrm>
            <a:off x="9143994" y="3863642"/>
            <a:ext cx="1040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avours blue light</a:t>
            </a:r>
          </a:p>
        </p:txBody>
      </p:sp>
    </p:spTree>
    <p:extLst>
      <p:ext uri="{BB962C8B-B14F-4D97-AF65-F5344CB8AC3E}">
        <p14:creationId xmlns:p14="http://schemas.microsoft.com/office/powerpoint/2010/main" val="968632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</TotalTime>
  <Words>20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ymond Lam</dc:creator>
  <cp:lastModifiedBy>Raymond Lam</cp:lastModifiedBy>
  <cp:revision>13</cp:revision>
  <dcterms:created xsi:type="dcterms:W3CDTF">2022-01-09T21:13:15Z</dcterms:created>
  <dcterms:modified xsi:type="dcterms:W3CDTF">2022-01-25T20:15:36Z</dcterms:modified>
</cp:coreProperties>
</file>